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3B6D36-D535-4FE1-909F-0396910397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153AE-8A83-492C-B915-4C6BEBC098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EF6E33-2D35-4B02-8A27-28939357FD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0D616-06BC-4EF4-9A54-A99F613E6F1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C30527-2763-4F59-9320-0210750284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595E48-1D7E-427D-BF15-23E956DA6B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0C7C7C-B353-425A-8EEB-B37601765F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E57F4B-9DD5-4B7A-8C10-F15A2C4CCA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7E25AA-E596-4807-8E03-8A28746748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E703E-2C2B-4128-899C-9413FCFE9B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A9FF2B-4635-4814-A590-1930D320BB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6299D-652D-4031-8E42-2F1B4A1B0B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66A693-3443-4F2F-B8F7-96C3EFC7F09F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6"/>
          <p:cNvSpPr/>
          <p:nvPr/>
        </p:nvSpPr>
        <p:spPr>
          <a:xfrm>
            <a:off x="7560" y="8831160"/>
            <a:ext cx="1104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正方形/長方形 40"/>
          <p:cNvSpPr/>
          <p:nvPr/>
        </p:nvSpPr>
        <p:spPr>
          <a:xfrm>
            <a:off x="476280" y="1442880"/>
            <a:ext cx="6337440" cy="496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ゴシック"/>
              </a:rPr>
              <a:t>Bold black: Locations of forward PCR prime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953735"/>
                </a:solidFill>
                <a:latin typeface="Arial"/>
                <a:ea typeface="ＭＳ ゴシック"/>
              </a:rPr>
              <a:t>Bold brown: Locations of reverse PCR prime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ゴシック"/>
              </a:rPr>
              <a:t>Black letters: non-LINE-1 seque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953735"/>
                </a:solidFill>
                <a:latin typeface="Arial"/>
                <a:ea typeface="ＭＳ ゴシック"/>
              </a:rPr>
              <a:t>Brown letters: LINE-1 seque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953735"/>
                </a:solidFill>
                <a:uFillTx/>
                <a:latin typeface="Arial"/>
                <a:ea typeface="ＭＳ ゴシック"/>
              </a:rPr>
              <a:t>Underlined</a:t>
            </a:r>
            <a:r>
              <a:rPr b="0" lang="en-US" sz="1000" spc="-1" strike="noStrike">
                <a:solidFill>
                  <a:srgbClr val="953735"/>
                </a:solidFill>
                <a:latin typeface="Arial"/>
                <a:ea typeface="ＭＳ ゴシック"/>
              </a:rPr>
              <a:t>: Locations of sequencing prime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ＭＳ ゴシック"/>
              </a:rPr>
              <a:t>Red: Analyzed sequenc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LINE-1 at a non-common breakpoi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Chr12: 71459893-71460153, 12q21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This LINE-1 is corresponding to the sequence of 1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ＭＳ ゴシック"/>
              </a:rPr>
              <a:t>st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– 22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ＭＳ ゴシック"/>
              </a:rPr>
              <a:t>rd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  nucleotides from L1P3 (5’UTR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TTGGATCACTGGCCATTTAAAATTG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CATAGTGTAGAA</a:t>
            </a:r>
            <a:r>
              <a:rPr b="0" lang="en-US" sz="1000" spc="-1" strike="noStrike">
                <a:solidFill>
                  <a:srgbClr val="953735"/>
                </a:solidFill>
                <a:latin typeface="Arial"/>
              </a:rPr>
              <a:t>GGTGGCTGGCAAGATGGCAGAATAGGAACAGCTCTGGTCTGCAGCTCCCAGCGAGATCAATGCAGAAGTGCAGAAGGTGGGTGATTTCTGCATTTCCAACTGAGGTACAAGGCTCATCTCACTGGGAA</a:t>
            </a:r>
            <a:r>
              <a:rPr b="1" lang="en-US" sz="1000" spc="-1" strike="noStrike">
                <a:solidFill>
                  <a:srgbClr val="953735"/>
                </a:solidFill>
                <a:latin typeface="Arial"/>
              </a:rPr>
              <a:t>CG</a:t>
            </a:r>
            <a:r>
              <a:rPr b="0" lang="en-US" sz="1000" spc="-1" strike="noStrike">
                <a:solidFill>
                  <a:srgbClr val="953735"/>
                </a:solidFill>
                <a:latin typeface="Arial"/>
              </a:rPr>
              <a:t>GTTAGACAGTGGGTGCAGCCCACCGAG</a:t>
            </a:r>
            <a:r>
              <a:rPr b="0" lang="en-US" sz="1000" spc="-1" strike="noStrike" u="sng">
                <a:solidFill>
                  <a:srgbClr val="953735"/>
                </a:solidFill>
                <a:uFillTx/>
                <a:latin typeface="Arial"/>
              </a:rPr>
              <a:t>GGTGAGCCGAAGCAGGGTGGGGCAG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GCAT</a:t>
            </a:r>
            <a:r>
              <a:rPr b="1" lang="en-US" sz="1000" spc="-1" strike="noStrike" u="sng">
                <a:solidFill>
                  <a:srgbClr val="ff0000"/>
                </a:solidFill>
                <a:uFillTx/>
                <a:latin typeface="Arial"/>
              </a:rPr>
              <a:t>CG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CCTTGCC</a:t>
            </a:r>
            <a:r>
              <a:rPr b="1" lang="en-US" sz="1000" spc="-1" strike="noStrike" u="sng">
                <a:solidFill>
                  <a:srgbClr val="ff0000"/>
                </a:solidFill>
                <a:uFillTx/>
                <a:latin typeface="Arial"/>
              </a:rPr>
              <a:t>CG</a:t>
            </a:r>
            <a:r>
              <a:rPr b="0" lang="en-US" sz="1000" spc="-1" strike="noStrike">
                <a:solidFill>
                  <a:srgbClr val="953735"/>
                </a:solidFill>
                <a:latin typeface="Arial"/>
              </a:rPr>
              <a:t>GGAA</a:t>
            </a:r>
            <a:r>
              <a:rPr b="1" lang="en-US" sz="1000" spc="-1" strike="noStrike">
                <a:solidFill>
                  <a:srgbClr val="953735"/>
                </a:solidFill>
                <a:latin typeface="Arial"/>
              </a:rPr>
              <a:t>GGGCAAGGGGGTCAGGGAAC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LINE-1 at a common breakpoi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chr12:11300102-11300473, 12p13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This LINE-1 is corresponding to the sequence of 2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ＭＳ ゴシック"/>
              </a:rPr>
              <a:t>rd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 – 248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ＭＳ ゴシック"/>
              </a:rPr>
              <a:t>th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  nucleotides from L1PA8 (5’UTR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AACTGCAGGGCCTGGGAAAGCAGATC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TCTTGAAATACAGAGTGCCCAACATAATAAATGAAAAAGACCTACATCAACTTATATCTAATTAAATCTTAATGATAAGAAAGATCTTGAAGATTCCACTTTAAAAAAGCGTCATGATG</a:t>
            </a:r>
            <a:r>
              <a:rPr b="0" lang="en-US" sz="1000" spc="-1" strike="noStrike">
                <a:solidFill>
                  <a:srgbClr val="953735"/>
                </a:solidFill>
                <a:latin typeface="Arial"/>
              </a:rPr>
              <a:t>TAGTAACAGCTCTGGTCTGCAGCTCCTAGCAAGATCAATGCAGAAGGCAGTTGATTTCTGCATTTCCAACTGAGCTACCCAGCTCATCTCACTGGGACTGGTTAGATAGTGGGTGCAGCCCAT</a:t>
            </a:r>
            <a:r>
              <a:rPr b="0" lang="en-US" sz="1000" spc="-1" strike="noStrike" u="sng">
                <a:solidFill>
                  <a:srgbClr val="953735"/>
                </a:solidFill>
                <a:uFillTx/>
                <a:latin typeface="Arial"/>
              </a:rPr>
              <a:t>GGAGGACAAGCAGAAGCAAGGTAGGGTG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T</a:t>
            </a:r>
            <a:r>
              <a:rPr b="1" lang="en-US" sz="1000" spc="-1" strike="noStrike" u="sng">
                <a:solidFill>
                  <a:srgbClr val="ff0000"/>
                </a:solidFill>
                <a:uFillTx/>
                <a:latin typeface="Arial"/>
              </a:rPr>
              <a:t>CG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CCTCACTC</a:t>
            </a:r>
            <a:r>
              <a:rPr b="1" lang="en-US" sz="1000" spc="-1" strike="noStrike" u="sng">
                <a:solidFill>
                  <a:srgbClr val="ff0000"/>
                </a:solidFill>
                <a:uFillTx/>
                <a:latin typeface="Arial"/>
              </a:rPr>
              <a:t>CG</a:t>
            </a:r>
            <a:r>
              <a:rPr b="0" lang="en-US" sz="1000" spc="-1" strike="noStrike">
                <a:solidFill>
                  <a:srgbClr val="953735"/>
                </a:solidFill>
                <a:latin typeface="Arial"/>
              </a:rPr>
              <a:t>GAAGTGCAAGGAGTTGGGAAACTCCCTCCCCTAGC</a:t>
            </a:r>
            <a:r>
              <a:rPr b="1" lang="en-US" sz="1000" spc="-1" strike="noStrike">
                <a:solidFill>
                  <a:srgbClr val="953735"/>
                </a:solidFill>
                <a:latin typeface="Arial"/>
              </a:rPr>
              <a:t>AAAGGGAAGCCATGACAGACTGTGC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LINE-1 at a common breakpoin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chr12:15031743-15031991, 12p12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This LINE-1 is corresponding to the sequence of 4672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ＭＳ ゴシック"/>
              </a:rPr>
              <a:t>nd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 – 488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ＭＳ ゴシック"/>
              </a:rPr>
              <a:t>rd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  nucleotides from L1PA16 (ORF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AAGTATTGGTTTGTCTTATATCTGTGG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ACAAATAGCCAAAG</a:t>
            </a:r>
            <a:r>
              <a:rPr b="0" lang="en-US" sz="1000" spc="-1" strike="noStrike">
                <a:solidFill>
                  <a:srgbClr val="953735"/>
                </a:solidFill>
                <a:latin typeface="Arial"/>
              </a:rPr>
              <a:t>CAAACCTAAGCAAGAAAGAACAAAGCCAGAGGCATCACATTACCCAACTTAAAACTATACTATATGGCTACAGTAACCA</a:t>
            </a:r>
            <a:r>
              <a:rPr b="0" lang="en-US" sz="1000" spc="-1" strike="noStrike" u="sng">
                <a:solidFill>
                  <a:srgbClr val="953735"/>
                </a:solidFill>
                <a:uFillTx/>
                <a:latin typeface="Arial"/>
              </a:rPr>
              <a:t>AAACAGCATGGTACAAAAACAGACATATAG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AC</a:t>
            </a:r>
            <a:r>
              <a:rPr b="1" lang="en-US" sz="1000" spc="-1" strike="noStrike" u="sng">
                <a:solidFill>
                  <a:srgbClr val="ff0000"/>
                </a:solidFill>
                <a:uFillTx/>
                <a:latin typeface="Arial"/>
              </a:rPr>
              <a:t>CG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GTGGAACAGAATAGGGAA</a:t>
            </a:r>
            <a:r>
              <a:rPr b="1" lang="en-US" sz="1000" spc="-1" strike="noStrike" u="sng">
                <a:solidFill>
                  <a:srgbClr val="ff0000"/>
                </a:solidFill>
                <a:uFillTx/>
                <a:latin typeface="Arial"/>
              </a:rPr>
              <a:t>CG</a:t>
            </a:r>
            <a:r>
              <a:rPr b="0" lang="en-US" sz="1000" spc="-1" strike="noStrike">
                <a:solidFill>
                  <a:srgbClr val="953735"/>
                </a:solidFill>
                <a:latin typeface="Arial"/>
              </a:rPr>
              <a:t>CAGAAATAAAGCTGCACATCTACAGCCATCTTATCTTTTACAGAGT</a:t>
            </a:r>
            <a:r>
              <a:rPr b="1" lang="en-US" sz="1000" spc="-1" strike="noStrike">
                <a:solidFill>
                  <a:srgbClr val="953735"/>
                </a:solidFill>
                <a:latin typeface="Arial"/>
              </a:rPr>
              <a:t>TGACAAAAATAAACAATGGAGAAAG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46"/>
          <p:cNvSpPr/>
          <p:nvPr/>
        </p:nvSpPr>
        <p:spPr>
          <a:xfrm>
            <a:off x="216000" y="192240"/>
            <a:ext cx="32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AutoShape 30"/>
          <p:cNvSpPr/>
          <p:nvPr/>
        </p:nvSpPr>
        <p:spPr>
          <a:xfrm>
            <a:off x="549360" y="193680"/>
            <a:ext cx="3168720" cy="11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32" descr=""/>
          <p:cNvPicPr/>
          <p:nvPr/>
        </p:nvPicPr>
        <p:blipFill>
          <a:blip r:embed="rId1"/>
          <a:stretch/>
        </p:blipFill>
        <p:spPr>
          <a:xfrm>
            <a:off x="692280" y="826920"/>
            <a:ext cx="2236680" cy="4683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34" descr=""/>
          <p:cNvPicPr/>
          <p:nvPr/>
        </p:nvPicPr>
        <p:blipFill>
          <a:blip r:embed="rId2"/>
          <a:stretch/>
        </p:blipFill>
        <p:spPr>
          <a:xfrm>
            <a:off x="1515960" y="952560"/>
            <a:ext cx="1790640" cy="45072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4" descr=""/>
          <p:cNvPicPr/>
          <p:nvPr/>
        </p:nvPicPr>
        <p:blipFill>
          <a:blip r:embed="rId3"/>
          <a:stretch/>
        </p:blipFill>
        <p:spPr>
          <a:xfrm>
            <a:off x="1341360" y="482760"/>
            <a:ext cx="4967280" cy="792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8" name="下矢印 48"/>
          <p:cNvSpPr/>
          <p:nvPr/>
        </p:nvSpPr>
        <p:spPr>
          <a:xfrm>
            <a:off x="1824120" y="165240"/>
            <a:ext cx="144360" cy="287280"/>
          </a:xfrm>
          <a:prstGeom prst="downArrow">
            <a:avLst>
              <a:gd name="adj1" fmla="val 50000"/>
              <a:gd name="adj2" fmla="val 50027"/>
            </a:avLst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下矢印 49"/>
          <p:cNvSpPr/>
          <p:nvPr/>
        </p:nvSpPr>
        <p:spPr>
          <a:xfrm>
            <a:off x="1989000" y="171360"/>
            <a:ext cx="142920" cy="289080"/>
          </a:xfrm>
          <a:prstGeom prst="downArrow">
            <a:avLst>
              <a:gd name="adj1" fmla="val 50000"/>
              <a:gd name="adj2" fmla="val 50014"/>
            </a:avLst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40"/>
          <p:cNvSpPr/>
          <p:nvPr/>
        </p:nvSpPr>
        <p:spPr>
          <a:xfrm>
            <a:off x="476280" y="677880"/>
            <a:ext cx="792000" cy="45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hr 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n = 1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52"/>
          <p:cNvSpPr/>
          <p:nvPr/>
        </p:nvSpPr>
        <p:spPr>
          <a:xfrm>
            <a:off x="1110600" y="193680"/>
            <a:ext cx="64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2p13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53"/>
          <p:cNvSpPr/>
          <p:nvPr/>
        </p:nvSpPr>
        <p:spPr>
          <a:xfrm>
            <a:off x="2078280" y="193680"/>
            <a:ext cx="64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2p12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46"/>
          <p:cNvSpPr/>
          <p:nvPr/>
        </p:nvSpPr>
        <p:spPr>
          <a:xfrm>
            <a:off x="189000" y="1415880"/>
            <a:ext cx="32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46"/>
          <p:cNvSpPr/>
          <p:nvPr/>
        </p:nvSpPr>
        <p:spPr>
          <a:xfrm>
            <a:off x="189000" y="6588000"/>
            <a:ext cx="32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16" descr=""/>
          <p:cNvPicPr/>
          <p:nvPr/>
        </p:nvPicPr>
        <p:blipFill>
          <a:blip r:embed="rId4"/>
          <a:stretch/>
        </p:blipFill>
        <p:spPr>
          <a:xfrm>
            <a:off x="692280" y="6659640"/>
            <a:ext cx="1944720" cy="1824120"/>
          </a:xfrm>
          <a:prstGeom prst="rect">
            <a:avLst/>
          </a:prstGeom>
          <a:ln w="0">
            <a:noFill/>
          </a:ln>
        </p:spPr>
      </p:pic>
      <p:sp>
        <p:nvSpPr>
          <p:cNvPr id="56" name="テキスト ボックス 17"/>
          <p:cNvSpPr/>
          <p:nvPr/>
        </p:nvSpPr>
        <p:spPr>
          <a:xfrm>
            <a:off x="959400" y="6659640"/>
            <a:ext cx="808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 = 0.58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lt; 0.00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18"/>
          <p:cNvSpPr/>
          <p:nvPr/>
        </p:nvSpPr>
        <p:spPr>
          <a:xfrm>
            <a:off x="4437000" y="7236000"/>
            <a:ext cx="184320" cy="27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33"/>
          <p:cNvSpPr/>
          <p:nvPr/>
        </p:nvSpPr>
        <p:spPr>
          <a:xfrm>
            <a:off x="878040" y="8345520"/>
            <a:ext cx="1830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ocal LINE-1 (L1PA8) 5’UTR (C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45"/>
          <p:cNvSpPr/>
          <p:nvPr/>
        </p:nvSpPr>
        <p:spPr>
          <a:xfrm rot="16200000">
            <a:off x="-266760" y="7282080"/>
            <a:ext cx="1868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ocal LINE-1 (L1P3) 5’UT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(non-breakpoin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3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8T01:53:55Z</dcterms:created>
  <dc:creator>MN2010</dc:creator>
  <dc:description/>
  <dc:language>en-US</dc:language>
  <cp:lastModifiedBy>MN2010</cp:lastModifiedBy>
  <dcterms:modified xsi:type="dcterms:W3CDTF">2012-12-14T01:22:46Z</dcterms:modified>
  <cp:revision>1158</cp:revision>
  <dc:subject/>
  <dc:title>スライド 1</dc:title>
</cp:coreProperties>
</file>